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87AD48-4DBF-4250-84C2-72C68FFBCD3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5AA686-2E7E-466B-9B07-D40E83643FF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A5B76B-7874-41D1-AB9C-27DD8C38720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04F557-6AFE-4D6F-935C-8CB170976B2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B0D2F8-603D-4F09-B0C0-F19A1769C3A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FF3D27-C005-4713-817A-3F67C884A9F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AFD3D3-BAFA-475E-A757-0114E5D0E1D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EB4D2D-BB8D-49F1-B009-F397E67A8F2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481773-7AB4-4018-ABAC-B27A9BA367A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320335-CB86-4A7F-9856-87F8B27FA40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8BA96F-1DAE-4745-B03F-C3EC5D92F26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84F401-48E5-4F50-BB2B-F351A0E1D06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3E0E9B7-130A-43B6-BCB9-6D758B7EB1BF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1371600" y="1523880"/>
            <a:ext cx="1600200" cy="9144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2133720" y="838080"/>
            <a:ext cx="0" cy="990720"/>
          </a:xfrm>
          <a:prstGeom prst="line">
            <a:avLst/>
          </a:prstGeom>
          <a:ln w="25560">
            <a:solidFill>
              <a:srgbClr val="000000"/>
            </a:solidFill>
            <a:miter/>
            <a:tailEnd len="lg" type="triangle" w="lg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1219320" y="228600"/>
            <a:ext cx="2438280" cy="611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600" spc="-1" strike="noStrike">
                <a:solidFill>
                  <a:srgbClr val="000000"/>
                </a:solidFill>
                <a:latin typeface="Arial"/>
              </a:rPr>
              <a:t>50 mosquitoes released into</a:t>
            </a:r>
            <a:r>
              <a:rPr b="0" lang="pt-BR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pt-BR" sz="1600" spc="-1" strike="noStrike">
                <a:solidFill>
                  <a:srgbClr val="000000"/>
                </a:solidFill>
                <a:latin typeface="Arial"/>
              </a:rPr>
              <a:t>room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4191120" y="1523880"/>
            <a:ext cx="1600200" cy="9144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3124080" y="1981080"/>
            <a:ext cx="83844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5105520" y="838080"/>
            <a:ext cx="0" cy="990720"/>
          </a:xfrm>
          <a:prstGeom prst="line">
            <a:avLst/>
          </a:prstGeom>
          <a:ln w="25560">
            <a:solidFill>
              <a:srgbClr val="000000"/>
            </a:solidFill>
            <a:miter/>
            <a:tailEnd len="lg" type="triangle" w="lg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4343400" y="228600"/>
            <a:ext cx="213372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600" spc="-1" strike="noStrike">
                <a:solidFill>
                  <a:srgbClr val="000000"/>
                </a:solidFill>
                <a:latin typeface="Arial"/>
              </a:rPr>
              <a:t>BG Sentinel placed in room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6858000" y="1523880"/>
            <a:ext cx="1600200" cy="9144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5867280" y="1905120"/>
            <a:ext cx="83844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6019920" y="2057400"/>
            <a:ext cx="609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24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6858000" y="1905120"/>
            <a:ext cx="16002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Arial"/>
              </a:rPr>
              <a:t>Number of surviving mosquitos count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 flipH="1">
            <a:off x="2971440" y="2438280"/>
            <a:ext cx="3809880" cy="144792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1295280" y="4114800"/>
            <a:ext cx="1600200" cy="9144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1066680" y="2971800"/>
            <a:ext cx="2590920" cy="95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600" spc="-1" strike="noStrike">
                <a:solidFill>
                  <a:srgbClr val="000000"/>
                </a:solidFill>
                <a:latin typeface="Arial"/>
              </a:rPr>
              <a:t>Another 50 mosquitoes released into room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2133720" y="3505320"/>
            <a:ext cx="0" cy="990360"/>
          </a:xfrm>
          <a:prstGeom prst="line">
            <a:avLst/>
          </a:prstGeom>
          <a:ln w="25560">
            <a:solidFill>
              <a:srgbClr val="000000"/>
            </a:solidFill>
            <a:miter/>
            <a:tailEnd len="lg" type="triangle" w="lg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4191120" y="4114800"/>
            <a:ext cx="1600200" cy="9144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3124080" y="4495680"/>
            <a:ext cx="83844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1600200" y="4495680"/>
            <a:ext cx="1066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ay 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4495680" y="4343400"/>
            <a:ext cx="1067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ay 1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1676520" y="1905120"/>
            <a:ext cx="914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ay 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4572000" y="1905120"/>
            <a:ext cx="1066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ay 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 flipV="1">
            <a:off x="4952880" y="4724280"/>
            <a:ext cx="0" cy="914400"/>
          </a:xfrm>
          <a:prstGeom prst="line">
            <a:avLst/>
          </a:prstGeom>
          <a:ln w="25560">
            <a:solidFill>
              <a:srgbClr val="000000"/>
            </a:solidFill>
            <a:miter/>
            <a:tailEnd len="lg" type="triangle" w="lg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4114800" y="5562720"/>
            <a:ext cx="213372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600" spc="-1" strike="noStrike">
                <a:solidFill>
                  <a:srgbClr val="000000"/>
                </a:solidFill>
                <a:latin typeface="Arial"/>
              </a:rPr>
              <a:t>BG Sentinel placed in room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5943600" y="4572000"/>
            <a:ext cx="83808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6019920" y="4724280"/>
            <a:ext cx="685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24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6858000" y="4114800"/>
            <a:ext cx="1600200" cy="9144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6934320" y="2819520"/>
            <a:ext cx="1523880" cy="36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1523880" y="1600200"/>
            <a:ext cx="228600" cy="30492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762120" y="1752480"/>
            <a:ext cx="83808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0" y="1371600"/>
            <a:ext cx="129528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BR" sz="1200" spc="-1" strike="noStrike">
                <a:solidFill>
                  <a:srgbClr val="000000"/>
                </a:solidFill>
                <a:latin typeface="Arial"/>
              </a:rPr>
              <a:t>Fungus impregnated cloths (5)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609480" y="6248520"/>
            <a:ext cx="7391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800" spc="-1" strike="noStrike">
                <a:solidFill>
                  <a:srgbClr val="000000"/>
                </a:solidFill>
                <a:latin typeface="Arial"/>
              </a:rPr>
              <a:t>*Same fungus impregnated cloths in rooms from day 0 to day 35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6934320" y="4495680"/>
            <a:ext cx="17524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Arial"/>
              </a:rPr>
              <a:t>Number of surviving mosquitos count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4343400" y="1600200"/>
            <a:ext cx="228600" cy="30492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1447920" y="4191120"/>
            <a:ext cx="228600" cy="30456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4267080" y="4191120"/>
            <a:ext cx="228600" cy="30456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7010280" y="1600200"/>
            <a:ext cx="228600" cy="30492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7010280" y="4191120"/>
            <a:ext cx="228600" cy="30456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3-23T22:31:16Z</dcterms:created>
  <dc:creator>Marinete</dc:creator>
  <dc:description/>
  <dc:language>en-US</dc:language>
  <cp:lastModifiedBy>LEF</cp:lastModifiedBy>
  <dcterms:modified xsi:type="dcterms:W3CDTF">2014-03-24T14:06:59Z</dcterms:modified>
  <cp:revision>3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